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5" d="100"/>
          <a:sy n="75" d="100"/>
        </p:scale>
        <p:origin x="307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cs-CZ"/>
              <a:t>Kliknutím můžete upravit styl předlohy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514826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225020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7635280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3357342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531493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985902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055828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Jenom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6289452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8021494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794026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cs-CZ"/>
              <a:t>Kliknutím na ikonu přidáte obrázek.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399766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500248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ovéPole 6"/>
          <p:cNvSpPr txBox="1"/>
          <p:nvPr/>
        </p:nvSpPr>
        <p:spPr>
          <a:xfrm>
            <a:off x="390307" y="6261239"/>
            <a:ext cx="6042578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/>
              <a:t>Figure</a:t>
            </a:r>
            <a:r>
              <a:rPr lang="en-US" sz="1100" dirty="0"/>
              <a:t> </a:t>
            </a:r>
            <a:r>
              <a:rPr lang="cs-CZ" sz="1100" b="1" dirty="0"/>
              <a:t>S</a:t>
            </a:r>
            <a:r>
              <a:rPr lang="en-US" sz="1100" b="1" dirty="0"/>
              <a:t>4.</a:t>
            </a:r>
            <a:r>
              <a:rPr lang="en-US" sz="1100" dirty="0"/>
              <a:t> </a:t>
            </a:r>
            <a:r>
              <a:rPr lang="en-US" sz="1100" b="1" dirty="0"/>
              <a:t>BABA perception affects gene expression of certain transcription factor families</a:t>
            </a:r>
            <a:r>
              <a:rPr lang="cs-CZ" sz="1100" i="1" dirty="0"/>
              <a:t>.</a:t>
            </a:r>
            <a:r>
              <a:rPr lang="en-US" sz="1100" b="1" dirty="0"/>
              <a:t> </a:t>
            </a:r>
            <a:r>
              <a:rPr lang="en-US" sz="1100" dirty="0"/>
              <a:t>The number of genes changed in transcription factor families. A ≥2-fold difference and P &lt;0.01 were used as cutoffs, asterisks indicate significantly enriched families determined by chi-square test.</a:t>
            </a:r>
          </a:p>
        </p:txBody>
      </p:sp>
      <p:grpSp>
        <p:nvGrpSpPr>
          <p:cNvPr id="11" name="Skupina 10"/>
          <p:cNvGrpSpPr/>
          <p:nvPr/>
        </p:nvGrpSpPr>
        <p:grpSpPr>
          <a:xfrm>
            <a:off x="390307" y="725847"/>
            <a:ext cx="6042578" cy="5311864"/>
            <a:chOff x="310096" y="437089"/>
            <a:chExt cx="6042578" cy="5311864"/>
          </a:xfrm>
        </p:grpSpPr>
        <p:pic>
          <p:nvPicPr>
            <p:cNvPr id="8" name="Obrázek 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10096" y="437089"/>
              <a:ext cx="6042578" cy="5311864"/>
            </a:xfrm>
            <a:prstGeom prst="rect">
              <a:avLst/>
            </a:prstGeom>
          </p:spPr>
        </p:pic>
        <p:sp>
          <p:nvSpPr>
            <p:cNvPr id="9" name="TextovéPole 8"/>
            <p:cNvSpPr txBox="1"/>
            <p:nvPr/>
          </p:nvSpPr>
          <p:spPr>
            <a:xfrm>
              <a:off x="667909" y="437089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*</a:t>
              </a:r>
              <a:endParaRPr lang="cs-CZ" sz="1200" dirty="0"/>
            </a:p>
          </p:txBody>
        </p:sp>
        <p:sp>
          <p:nvSpPr>
            <p:cNvPr id="10" name="TextovéPole 9"/>
            <p:cNvSpPr txBox="1"/>
            <p:nvPr/>
          </p:nvSpPr>
          <p:spPr>
            <a:xfrm>
              <a:off x="568208" y="575588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*</a:t>
              </a:r>
              <a:endParaRPr lang="cs-CZ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21808450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Motiv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iv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iv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6</TotalTime>
  <Words>50</Words>
  <Application>Microsoft Office PowerPoint</Application>
  <PresentationFormat>A4 (210 × 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Použitá písma</vt:lpstr>
      </vt:variant>
      <vt:variant>
        <vt:i4>3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iv Office</vt:lpstr>
      <vt:lpstr>Prezentace aplikac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lochik</dc:creator>
  <cp:lastModifiedBy>Jan Lochman</cp:lastModifiedBy>
  <cp:revision>14</cp:revision>
  <dcterms:created xsi:type="dcterms:W3CDTF">2018-04-26T14:11:40Z</dcterms:created>
  <dcterms:modified xsi:type="dcterms:W3CDTF">2023-03-02T07:54:32Z</dcterms:modified>
</cp:coreProperties>
</file>